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126" y="3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981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4467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9644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248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7219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6116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491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4198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762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5138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0699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AEA33-751A-40AB-9F16-B3BCF1672213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57D57-4C4C-41FE-8A47-725A4D981E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4183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698" y="577260"/>
            <a:ext cx="8004603" cy="430906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33425" y="5000625"/>
            <a:ext cx="8001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A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Distribution of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mbly lengths f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d BAC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imum tiling path for physical map version LTC-18(2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3329340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0163" y="233802"/>
            <a:ext cx="7403674" cy="510972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00151" y="5524500"/>
            <a:ext cx="69723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B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N50s fo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d BACs in the minimum tiling path for physical map version LTC-18(2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5796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46</Words>
  <Application>Microsoft Office PowerPoint</Application>
  <PresentationFormat>On-screen Show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Armstead [ipa]</dc:creator>
  <cp:lastModifiedBy>Ian Armstead [ipa]</cp:lastModifiedBy>
  <cp:revision>10</cp:revision>
  <dcterms:created xsi:type="dcterms:W3CDTF">2018-06-11T08:51:42Z</dcterms:created>
  <dcterms:modified xsi:type="dcterms:W3CDTF">2018-11-09T09:31:34Z</dcterms:modified>
</cp:coreProperties>
</file>